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>
      <p:cViewPr varScale="1">
        <p:scale>
          <a:sx n="114" d="100"/>
          <a:sy n="114" d="100"/>
        </p:scale>
        <p:origin x="47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7B3C69-57EE-25BF-414E-BBA4BD0201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2FE12A-A0AC-6602-D3C0-F3C65CE9CF3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4DF8DC-3CBE-D7E8-67AD-D4CDA5EB1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AE1C2-5B9B-49E4-A618-CF981985C03E}" type="datetimeFigureOut">
              <a:rPr lang="en-CA" smtClean="0"/>
              <a:t>2024-01-3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599FF4-2D74-E391-688C-97233944E6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A875B1-C244-E579-1E76-F4917EE8A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6D0-8E8B-4D34-A4B0-A92113970B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17508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EF30BC-0E9F-4D85-BB07-D7D32AA306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C83E24-4341-F53A-ED71-27826CEC4C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6EF383-69D6-357D-66A2-FEFA7197CE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AE1C2-5B9B-49E4-A618-CF981985C03E}" type="datetimeFigureOut">
              <a:rPr lang="en-CA" smtClean="0"/>
              <a:t>2024-01-3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9A8390-8DBF-9FAB-8A8A-10E50730D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690AFA-BF75-B9E0-0F71-0267B64B8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6D0-8E8B-4D34-A4B0-A92113970B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0756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D852691-2186-F6A0-7059-BF7A4ADBAE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CF813A-6D5E-BC08-41AC-A64C67F6D4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4941E8-C1D5-226E-70E5-04D9532E3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AE1C2-5B9B-49E4-A618-CF981985C03E}" type="datetimeFigureOut">
              <a:rPr lang="en-CA" smtClean="0"/>
              <a:t>2024-01-3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E6ABAA-055F-8A2B-7835-2D3D2A0B1C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F4CA2B-D458-3C36-4ED8-BBEE486189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6D0-8E8B-4D34-A4B0-A92113970B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39368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670843-132E-33CF-5CE6-86B0E3990D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74E2D8-CE74-F703-FE88-E8124A8AEC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0F4741-1B8C-0965-0AEC-66928DF21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AE1C2-5B9B-49E4-A618-CF981985C03E}" type="datetimeFigureOut">
              <a:rPr lang="en-CA" smtClean="0"/>
              <a:t>2024-01-3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1C0988-DA1B-4640-CDF1-84A7A0D90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60F6D1-61CD-ECDB-933C-708E096CE0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6D0-8E8B-4D34-A4B0-A92113970B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46989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D6B7D4-6272-4577-6411-2701997100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0F7B6A-5964-A03C-F41F-62C0EE5C07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4BBFDB-954C-0231-8CB5-11B5FD52F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AE1C2-5B9B-49E4-A618-CF981985C03E}" type="datetimeFigureOut">
              <a:rPr lang="en-CA" smtClean="0"/>
              <a:t>2024-01-3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49D55D-5F4E-B598-DE6B-0733F828E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EFA3CD-92E4-D98A-FFA4-8139DB66F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6D0-8E8B-4D34-A4B0-A92113970B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39818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E6C79C-1261-0952-185E-814A8E56DC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714B97-3159-E193-AF38-F166AED0F9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A47758-9F1F-9FE9-2A51-F1FB951751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E8E4B7-4394-DB6C-FA0A-BFAD439FC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AE1C2-5B9B-49E4-A618-CF981985C03E}" type="datetimeFigureOut">
              <a:rPr lang="en-CA" smtClean="0"/>
              <a:t>2024-01-3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7B2FFD-18C5-A390-9A5E-E0EDFA65B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B9D160-56F6-5686-0316-16D77269D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6D0-8E8B-4D34-A4B0-A92113970B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9832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3C9838-D5A3-D127-8DF1-1F08A25CD1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3F384C-913D-60E1-8FE6-8383EEAD46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EC199D-A36F-AFC2-D13E-C8DB7B7802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3D13E8-531F-AB4B-5B6E-F7D42CABC1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75558C8-47B1-762A-A353-32B4DF0F99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5A59EDD-1F0C-EDB8-93CC-7FC7E0259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AE1C2-5B9B-49E4-A618-CF981985C03E}" type="datetimeFigureOut">
              <a:rPr lang="en-CA" smtClean="0"/>
              <a:t>2024-01-30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013164D-9419-C7D3-4621-16983021C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63C831F-54C9-09A9-FFB9-85EEAF895D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6D0-8E8B-4D34-A4B0-A92113970B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02982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D7277F-836E-225B-4EF1-6D56132A49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B9C0808-7290-965A-E46E-7CD0CB572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AE1C2-5B9B-49E4-A618-CF981985C03E}" type="datetimeFigureOut">
              <a:rPr lang="en-CA" smtClean="0"/>
              <a:t>2024-01-30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974C96F-8544-A326-F7F3-AE3D28392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4223A0A-0430-C6C8-B3F6-7A9B7EF66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6D0-8E8B-4D34-A4B0-A92113970B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67943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545C8BB-2DD9-EF2B-AF33-D163887BF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AE1C2-5B9B-49E4-A618-CF981985C03E}" type="datetimeFigureOut">
              <a:rPr lang="en-CA" smtClean="0"/>
              <a:t>2024-01-30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32C323-E364-103D-36AD-341FB7547E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EBD6E2-6FEB-CAB5-32A6-8F1957D2A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6D0-8E8B-4D34-A4B0-A92113970B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20095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D71092-5250-5520-FB25-17975C237D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2EC043-A79F-808A-B664-0A9401F7C10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C06417-71D3-C63E-9ACE-7969F78937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C3D21D-73F1-B4FB-1DE8-06968F7C1A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AE1C2-5B9B-49E4-A618-CF981985C03E}" type="datetimeFigureOut">
              <a:rPr lang="en-CA" smtClean="0"/>
              <a:t>2024-01-3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12202F-F821-B90E-2F4C-EC77CC69FC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33459E-B973-41F5-C826-70AF785E1A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6D0-8E8B-4D34-A4B0-A92113970B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33876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993774-BE7F-1FD8-8477-0201424F73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EA26E37-F9B5-92AE-EEE9-177D5F9353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5F5A11-3755-73D0-F8D3-84CC3B3359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6B6540-5B19-031F-ACA9-99356C947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AE1C2-5B9B-49E4-A618-CF981985C03E}" type="datetimeFigureOut">
              <a:rPr lang="en-CA" smtClean="0"/>
              <a:t>2024-01-3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A269C-D350-C78F-C4B8-0FA788C17F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E59C8A-AA3B-3A97-7732-13982D0AE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6D0-8E8B-4D34-A4B0-A92113970B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04056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578E51E-33D6-8858-C073-4766D44842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F161B1-920E-E68B-8D33-FC61695980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7CED57-C8B5-7728-FE80-54FC54BA91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AE1C2-5B9B-49E4-A618-CF981985C03E}" type="datetimeFigureOut">
              <a:rPr lang="en-CA" smtClean="0"/>
              <a:t>2024-01-3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B3D2C3-213D-2EBC-ED7F-3F24A6F3C6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7EA6B4-BE02-B95F-6DA8-3894734059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CB86D0-8E8B-4D34-A4B0-A92113970B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02885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60AD7802-26E3-61E0-56B3-E28F48F3FD1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490481" y="1268760"/>
            <a:ext cx="5868219" cy="437258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F44FECF-DBB4-56DD-5914-9A4B70832179}"/>
              </a:ext>
            </a:extLst>
          </p:cNvPr>
          <p:cNvSpPr txBox="1"/>
          <p:nvPr/>
        </p:nvSpPr>
        <p:spPr>
          <a:xfrm>
            <a:off x="513985" y="202105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25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A37D42C-BC14-080C-20B0-3DAAAF0DC4F2}"/>
              </a:ext>
            </a:extLst>
          </p:cNvPr>
          <p:cNvSpPr txBox="1"/>
          <p:nvPr/>
        </p:nvSpPr>
        <p:spPr>
          <a:xfrm>
            <a:off x="490481" y="2454870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15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AA5C5C9-CC03-903D-727E-DE616F9D1BF7}"/>
              </a:ext>
            </a:extLst>
          </p:cNvPr>
          <p:cNvSpPr txBox="1"/>
          <p:nvPr/>
        </p:nvSpPr>
        <p:spPr>
          <a:xfrm>
            <a:off x="490481" y="2926025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10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5C58C84-5B9D-91B2-9E7F-C62D4DA87767}"/>
              </a:ext>
            </a:extLst>
          </p:cNvPr>
          <p:cNvSpPr txBox="1"/>
          <p:nvPr/>
        </p:nvSpPr>
        <p:spPr>
          <a:xfrm>
            <a:off x="490481" y="3290500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75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69E179EE-DD8E-DB98-EB14-93011424EA9C}"/>
              </a:ext>
            </a:extLst>
          </p:cNvPr>
          <p:cNvCxnSpPr>
            <a:cxnSpLocks/>
          </p:cNvCxnSpPr>
          <p:nvPr/>
        </p:nvCxnSpPr>
        <p:spPr>
          <a:xfrm flipH="1">
            <a:off x="6005656" y="4005064"/>
            <a:ext cx="5760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813828CA-351E-A5B9-6232-E73BB630CB15}"/>
              </a:ext>
            </a:extLst>
          </p:cNvPr>
          <p:cNvSpPr txBox="1"/>
          <p:nvPr/>
        </p:nvSpPr>
        <p:spPr>
          <a:xfrm>
            <a:off x="6755177" y="3820398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pTBK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4898AA2-4E46-635D-807F-A7AE2AC78BEE}"/>
              </a:ext>
            </a:extLst>
          </p:cNvPr>
          <p:cNvSpPr txBox="1"/>
          <p:nvPr/>
        </p:nvSpPr>
        <p:spPr>
          <a:xfrm>
            <a:off x="1198133" y="484608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 err="1"/>
              <a:t>Veh</a:t>
            </a:r>
            <a:endParaRPr lang="en-CA" sz="14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F8C5E44-A50B-A890-310C-990EB0360B6C}"/>
              </a:ext>
            </a:extLst>
          </p:cNvPr>
          <p:cNvSpPr txBox="1"/>
          <p:nvPr/>
        </p:nvSpPr>
        <p:spPr>
          <a:xfrm>
            <a:off x="1721514" y="484608"/>
            <a:ext cx="576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ADU 10 1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A755781-7054-2A44-DA9F-CA72666E478E}"/>
              </a:ext>
            </a:extLst>
          </p:cNvPr>
          <p:cNvSpPr txBox="1"/>
          <p:nvPr/>
        </p:nvSpPr>
        <p:spPr>
          <a:xfrm>
            <a:off x="2279576" y="484608"/>
            <a:ext cx="576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ADU 30 1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8C7EECE-CEC6-4DC5-B3BD-DE456E069DDF}"/>
              </a:ext>
            </a:extLst>
          </p:cNvPr>
          <p:cNvSpPr txBox="1"/>
          <p:nvPr/>
        </p:nvSpPr>
        <p:spPr>
          <a:xfrm>
            <a:off x="2819636" y="484608"/>
            <a:ext cx="576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ADU 10 3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31610E9-6A31-A5BF-F812-D060D68995B3}"/>
              </a:ext>
            </a:extLst>
          </p:cNvPr>
          <p:cNvSpPr txBox="1"/>
          <p:nvPr/>
        </p:nvSpPr>
        <p:spPr>
          <a:xfrm>
            <a:off x="3251684" y="484608"/>
            <a:ext cx="576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ADU 30</a:t>
            </a:r>
          </a:p>
          <a:p>
            <a:pPr algn="ctr"/>
            <a:r>
              <a:rPr lang="en-CA" sz="1400" dirty="0"/>
              <a:t>3h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BE0C08F-060F-C673-B3CD-EEC4D7763B91}"/>
              </a:ext>
            </a:extLst>
          </p:cNvPr>
          <p:cNvSpPr txBox="1"/>
          <p:nvPr/>
        </p:nvSpPr>
        <p:spPr>
          <a:xfrm>
            <a:off x="3757063" y="484608"/>
            <a:ext cx="576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ADU 10</a:t>
            </a:r>
          </a:p>
          <a:p>
            <a:pPr algn="ctr"/>
            <a:r>
              <a:rPr lang="en-CA" sz="1400" dirty="0"/>
              <a:t>6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442BDA4-70EE-6A05-40E2-4BEA0F8B3A3B}"/>
              </a:ext>
            </a:extLst>
          </p:cNvPr>
          <p:cNvSpPr txBox="1"/>
          <p:nvPr/>
        </p:nvSpPr>
        <p:spPr>
          <a:xfrm>
            <a:off x="4189111" y="484608"/>
            <a:ext cx="576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ADU 30 6h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9445BF1-29CF-9104-09AC-18457E02A8FF}"/>
              </a:ext>
            </a:extLst>
          </p:cNvPr>
          <p:cNvSpPr txBox="1"/>
          <p:nvPr/>
        </p:nvSpPr>
        <p:spPr>
          <a:xfrm>
            <a:off x="4691844" y="484608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 err="1"/>
              <a:t>Veh</a:t>
            </a:r>
            <a:endParaRPr lang="en-CA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0EB2A26-D55F-758F-EE32-C8F44337D4EE}"/>
              </a:ext>
            </a:extLst>
          </p:cNvPr>
          <p:cNvSpPr txBox="1"/>
          <p:nvPr/>
        </p:nvSpPr>
        <p:spPr>
          <a:xfrm>
            <a:off x="5267908" y="484608"/>
            <a:ext cx="576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ADU 30 3h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83A7291-DFC7-5270-6833-BD216466089D}"/>
              </a:ext>
            </a:extLst>
          </p:cNvPr>
          <p:cNvCxnSpPr>
            <a:cxnSpLocks/>
          </p:cNvCxnSpPr>
          <p:nvPr/>
        </p:nvCxnSpPr>
        <p:spPr>
          <a:xfrm>
            <a:off x="1487488" y="332656"/>
            <a:ext cx="320435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24DC181A-E66F-3F7B-EC65-866EF784CE59}"/>
              </a:ext>
            </a:extLst>
          </p:cNvPr>
          <p:cNvSpPr txBox="1"/>
          <p:nvPr/>
        </p:nvSpPr>
        <p:spPr>
          <a:xfrm>
            <a:off x="2801634" y="2581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W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55F3EB7-9713-C3D3-3501-635B2743E747}"/>
              </a:ext>
            </a:extLst>
          </p:cNvPr>
          <p:cNvSpPr txBox="1"/>
          <p:nvPr/>
        </p:nvSpPr>
        <p:spPr>
          <a:xfrm>
            <a:off x="4765175" y="37566"/>
            <a:ext cx="10054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STING-/-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018554B5-1301-C954-E070-ACEF3A0B5A6B}"/>
              </a:ext>
            </a:extLst>
          </p:cNvPr>
          <p:cNvCxnSpPr>
            <a:cxnSpLocks/>
          </p:cNvCxnSpPr>
          <p:nvPr/>
        </p:nvCxnSpPr>
        <p:spPr>
          <a:xfrm>
            <a:off x="4871864" y="332656"/>
            <a:ext cx="89877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844253E1-5FDA-5E17-635B-340DEFE47C69}"/>
              </a:ext>
            </a:extLst>
          </p:cNvPr>
          <p:cNvSpPr txBox="1"/>
          <p:nvPr/>
        </p:nvSpPr>
        <p:spPr>
          <a:xfrm>
            <a:off x="6303290" y="299013"/>
            <a:ext cx="36091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ull unedited gel for Figure 2A</a:t>
            </a:r>
            <a:endParaRPr lang="en-CA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104583A-B588-9D43-A838-1B5DCB449B0E}"/>
              </a:ext>
            </a:extLst>
          </p:cNvPr>
          <p:cNvSpPr txBox="1"/>
          <p:nvPr/>
        </p:nvSpPr>
        <p:spPr>
          <a:xfrm>
            <a:off x="5545084" y="712924"/>
            <a:ext cx="9211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ug/ml</a:t>
            </a:r>
          </a:p>
        </p:txBody>
      </p:sp>
    </p:spTree>
    <p:extLst>
      <p:ext uri="{BB962C8B-B14F-4D97-AF65-F5344CB8AC3E}">
        <p14:creationId xmlns:p14="http://schemas.microsoft.com/office/powerpoint/2010/main" val="19591924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 descr="A close-up of a tissue&#10;&#10;Description automatically generated">
            <a:extLst>
              <a:ext uri="{FF2B5EF4-FFF2-40B4-BE49-F238E27FC236}">
                <a16:creationId xmlns:a16="http://schemas.microsoft.com/office/drawing/2014/main" id="{AEA54FF5-9818-F2B0-F4A0-E06DA9E21E7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1887"/>
          <a:stretch/>
        </p:blipFill>
        <p:spPr>
          <a:xfrm>
            <a:off x="54742" y="1239567"/>
            <a:ext cx="7488878" cy="4372584"/>
          </a:xfrm>
          <a:prstGeom prst="rect">
            <a:avLst/>
          </a:prstGeom>
        </p:spPr>
      </p:pic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C4DC1288-AC22-76DD-BDF3-C9CD8D77A6E7}"/>
              </a:ext>
            </a:extLst>
          </p:cNvPr>
          <p:cNvCxnSpPr>
            <a:cxnSpLocks/>
            <a:stCxn id="22" idx="1"/>
          </p:cNvCxnSpPr>
          <p:nvPr/>
        </p:nvCxnSpPr>
        <p:spPr>
          <a:xfrm flipH="1">
            <a:off x="6282583" y="4117722"/>
            <a:ext cx="138651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4F980DE1-AAD8-D6B4-C657-B2D2084FAB09}"/>
              </a:ext>
            </a:extLst>
          </p:cNvPr>
          <p:cNvSpPr txBox="1"/>
          <p:nvPr/>
        </p:nvSpPr>
        <p:spPr>
          <a:xfrm>
            <a:off x="7669093" y="3933056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TBK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6B7CA10-865B-44B4-A9B8-0FEEC73F57DA}"/>
              </a:ext>
            </a:extLst>
          </p:cNvPr>
          <p:cNvSpPr txBox="1"/>
          <p:nvPr/>
        </p:nvSpPr>
        <p:spPr>
          <a:xfrm>
            <a:off x="511269" y="2016402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25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4B0FF90-C9D0-154A-D8AC-21D0537506D5}"/>
              </a:ext>
            </a:extLst>
          </p:cNvPr>
          <p:cNvSpPr txBox="1"/>
          <p:nvPr/>
        </p:nvSpPr>
        <p:spPr>
          <a:xfrm>
            <a:off x="487765" y="245022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15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789AFE8-7A1C-8262-4ADB-4E8208785114}"/>
              </a:ext>
            </a:extLst>
          </p:cNvPr>
          <p:cNvSpPr txBox="1"/>
          <p:nvPr/>
        </p:nvSpPr>
        <p:spPr>
          <a:xfrm>
            <a:off x="487765" y="2921376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10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FB8646E-6E97-855F-F38B-B0DF04C3FBAD}"/>
              </a:ext>
            </a:extLst>
          </p:cNvPr>
          <p:cNvSpPr txBox="1"/>
          <p:nvPr/>
        </p:nvSpPr>
        <p:spPr>
          <a:xfrm>
            <a:off x="487765" y="328585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75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BC78EBD4-C638-55D7-60A5-FD52F3828DD8}"/>
              </a:ext>
            </a:extLst>
          </p:cNvPr>
          <p:cNvCxnSpPr>
            <a:cxnSpLocks/>
          </p:cNvCxnSpPr>
          <p:nvPr/>
        </p:nvCxnSpPr>
        <p:spPr>
          <a:xfrm>
            <a:off x="487765" y="2293401"/>
            <a:ext cx="3489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36CBF3D9-6751-3180-93E8-20878E5220C8}"/>
              </a:ext>
            </a:extLst>
          </p:cNvPr>
          <p:cNvCxnSpPr>
            <a:cxnSpLocks/>
          </p:cNvCxnSpPr>
          <p:nvPr/>
        </p:nvCxnSpPr>
        <p:spPr>
          <a:xfrm>
            <a:off x="487765" y="2727220"/>
            <a:ext cx="3489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C98D1255-6CBD-AB10-72A3-104C559F9B85}"/>
              </a:ext>
            </a:extLst>
          </p:cNvPr>
          <p:cNvCxnSpPr>
            <a:cxnSpLocks/>
          </p:cNvCxnSpPr>
          <p:nvPr/>
        </p:nvCxnSpPr>
        <p:spPr>
          <a:xfrm>
            <a:off x="511269" y="3205220"/>
            <a:ext cx="3489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3F903228-42DC-274E-D25B-127C4E8FCADE}"/>
              </a:ext>
            </a:extLst>
          </p:cNvPr>
          <p:cNvCxnSpPr>
            <a:cxnSpLocks/>
          </p:cNvCxnSpPr>
          <p:nvPr/>
        </p:nvCxnSpPr>
        <p:spPr>
          <a:xfrm>
            <a:off x="487765" y="3611468"/>
            <a:ext cx="3489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A0389A22-32E2-07F8-B366-D68ACA3D684D}"/>
              </a:ext>
            </a:extLst>
          </p:cNvPr>
          <p:cNvSpPr txBox="1"/>
          <p:nvPr/>
        </p:nvSpPr>
        <p:spPr>
          <a:xfrm>
            <a:off x="6303290" y="299013"/>
            <a:ext cx="36091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ull unedited gel for Figure 2A</a:t>
            </a:r>
            <a:endParaRPr lang="en-CA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CCE0A0B-297B-8060-8633-E6191FEF3633}"/>
              </a:ext>
            </a:extLst>
          </p:cNvPr>
          <p:cNvSpPr txBox="1"/>
          <p:nvPr/>
        </p:nvSpPr>
        <p:spPr>
          <a:xfrm>
            <a:off x="1198133" y="484608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 err="1"/>
              <a:t>Veh</a:t>
            </a:r>
            <a:endParaRPr lang="en-CA" sz="14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7AFA853-5615-CE09-A744-6676C660EEA9}"/>
              </a:ext>
            </a:extLst>
          </p:cNvPr>
          <p:cNvSpPr txBox="1"/>
          <p:nvPr/>
        </p:nvSpPr>
        <p:spPr>
          <a:xfrm>
            <a:off x="1721514" y="484608"/>
            <a:ext cx="576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ADU 10 1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F50EE5-7661-BBA5-5D9F-BE5944DE447C}"/>
              </a:ext>
            </a:extLst>
          </p:cNvPr>
          <p:cNvSpPr txBox="1"/>
          <p:nvPr/>
        </p:nvSpPr>
        <p:spPr>
          <a:xfrm>
            <a:off x="2279576" y="484608"/>
            <a:ext cx="576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ADU 30 1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3ADAAA8-1560-BB3C-3966-2F8FC7998CA3}"/>
              </a:ext>
            </a:extLst>
          </p:cNvPr>
          <p:cNvSpPr txBox="1"/>
          <p:nvPr/>
        </p:nvSpPr>
        <p:spPr>
          <a:xfrm>
            <a:off x="2819636" y="484608"/>
            <a:ext cx="576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ADU 10 3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44E474A-DACF-6A92-34D6-64418DBF886B}"/>
              </a:ext>
            </a:extLst>
          </p:cNvPr>
          <p:cNvSpPr txBox="1"/>
          <p:nvPr/>
        </p:nvSpPr>
        <p:spPr>
          <a:xfrm>
            <a:off x="3251684" y="484608"/>
            <a:ext cx="576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ADU 30</a:t>
            </a:r>
          </a:p>
          <a:p>
            <a:pPr algn="ctr"/>
            <a:r>
              <a:rPr lang="en-CA" sz="1400" dirty="0"/>
              <a:t>3h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26BF212-1CDE-7CE0-4AB2-9C2C5B96553B}"/>
              </a:ext>
            </a:extLst>
          </p:cNvPr>
          <p:cNvSpPr txBox="1"/>
          <p:nvPr/>
        </p:nvSpPr>
        <p:spPr>
          <a:xfrm>
            <a:off x="3757063" y="484608"/>
            <a:ext cx="576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ADU 10</a:t>
            </a:r>
          </a:p>
          <a:p>
            <a:pPr algn="ctr"/>
            <a:r>
              <a:rPr lang="en-CA" sz="1400" dirty="0"/>
              <a:t>6h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BC8CA54-ED74-9548-D913-E27F03FD5E96}"/>
              </a:ext>
            </a:extLst>
          </p:cNvPr>
          <p:cNvSpPr txBox="1"/>
          <p:nvPr/>
        </p:nvSpPr>
        <p:spPr>
          <a:xfrm>
            <a:off x="4189111" y="484608"/>
            <a:ext cx="576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ADU 30 6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B06F83A-6B7C-7860-BA00-1F9D184AF069}"/>
              </a:ext>
            </a:extLst>
          </p:cNvPr>
          <p:cNvSpPr txBox="1"/>
          <p:nvPr/>
        </p:nvSpPr>
        <p:spPr>
          <a:xfrm>
            <a:off x="4691844" y="484608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 err="1"/>
              <a:t>Veh</a:t>
            </a:r>
            <a:endParaRPr lang="en-CA"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7EC7E62-DD7C-12AF-0661-50BCA8FE7CE0}"/>
              </a:ext>
            </a:extLst>
          </p:cNvPr>
          <p:cNvSpPr txBox="1"/>
          <p:nvPr/>
        </p:nvSpPr>
        <p:spPr>
          <a:xfrm>
            <a:off x="5267908" y="484608"/>
            <a:ext cx="576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ADU 30 3h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FE5D87BD-CDA1-5490-D034-EE16FAAF3AA5}"/>
              </a:ext>
            </a:extLst>
          </p:cNvPr>
          <p:cNvCxnSpPr>
            <a:cxnSpLocks/>
          </p:cNvCxnSpPr>
          <p:nvPr/>
        </p:nvCxnSpPr>
        <p:spPr>
          <a:xfrm>
            <a:off x="1487488" y="332656"/>
            <a:ext cx="320435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D0E8ACEF-B53F-B389-A924-00D7A63D5D6E}"/>
              </a:ext>
            </a:extLst>
          </p:cNvPr>
          <p:cNvSpPr txBox="1"/>
          <p:nvPr/>
        </p:nvSpPr>
        <p:spPr>
          <a:xfrm>
            <a:off x="2801634" y="2581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W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452024E-2D55-36BC-BBCE-742C28B219AF}"/>
              </a:ext>
            </a:extLst>
          </p:cNvPr>
          <p:cNvSpPr txBox="1"/>
          <p:nvPr/>
        </p:nvSpPr>
        <p:spPr>
          <a:xfrm>
            <a:off x="4765175" y="37566"/>
            <a:ext cx="10054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STING-/-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D18AEC7C-AFF3-C7F4-17CA-7F86A6B09C15}"/>
              </a:ext>
            </a:extLst>
          </p:cNvPr>
          <p:cNvCxnSpPr>
            <a:cxnSpLocks/>
          </p:cNvCxnSpPr>
          <p:nvPr/>
        </p:nvCxnSpPr>
        <p:spPr>
          <a:xfrm>
            <a:off x="4871864" y="332656"/>
            <a:ext cx="89877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71A0F38C-FB51-9164-A794-F949B9D088FA}"/>
              </a:ext>
            </a:extLst>
          </p:cNvPr>
          <p:cNvSpPr txBox="1"/>
          <p:nvPr/>
        </p:nvSpPr>
        <p:spPr>
          <a:xfrm>
            <a:off x="5545084" y="712924"/>
            <a:ext cx="9211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/>
              <a:t>ug/ml</a:t>
            </a:r>
          </a:p>
        </p:txBody>
      </p:sp>
    </p:spTree>
    <p:extLst>
      <p:ext uri="{BB962C8B-B14F-4D97-AF65-F5344CB8AC3E}">
        <p14:creationId xmlns:p14="http://schemas.microsoft.com/office/powerpoint/2010/main" val="33970683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 descr="A close-up of a dna test&#10;&#10;Description automatically generated">
            <a:extLst>
              <a:ext uri="{FF2B5EF4-FFF2-40B4-BE49-F238E27FC236}">
                <a16:creationId xmlns:a16="http://schemas.microsoft.com/office/drawing/2014/main" id="{5E41F7CB-9D67-119C-7F99-9628BE4F3A6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414" b="45697"/>
          <a:stretch/>
        </p:blipFill>
        <p:spPr>
          <a:xfrm>
            <a:off x="820748" y="3694003"/>
            <a:ext cx="5275252" cy="1410689"/>
          </a:xfrm>
          <a:prstGeom prst="rect">
            <a:avLst/>
          </a:prstGeom>
        </p:spPr>
      </p:pic>
      <p:pic>
        <p:nvPicPr>
          <p:cNvPr id="4" name="Picture 3" descr="A close up of a piece of paper&#10;&#10;Description automatically generated">
            <a:extLst>
              <a:ext uri="{FF2B5EF4-FFF2-40B4-BE49-F238E27FC236}">
                <a16:creationId xmlns:a16="http://schemas.microsoft.com/office/drawing/2014/main" id="{4A3525D2-9764-0F96-C131-F96C627D532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331" b="36279"/>
          <a:stretch/>
        </p:blipFill>
        <p:spPr>
          <a:xfrm>
            <a:off x="802837" y="1368683"/>
            <a:ext cx="5598433" cy="1630995"/>
          </a:xfrm>
          <a:prstGeom prst="rect">
            <a:avLst/>
          </a:prstGeom>
        </p:spPr>
      </p:pic>
      <p:sp>
        <p:nvSpPr>
          <p:cNvPr id="92" name="TextBox 91">
            <a:extLst>
              <a:ext uri="{FF2B5EF4-FFF2-40B4-BE49-F238E27FC236}">
                <a16:creationId xmlns:a16="http://schemas.microsoft.com/office/drawing/2014/main" id="{4EEC1377-1220-3FEE-37E7-A01DB0F586D9}"/>
              </a:ext>
            </a:extLst>
          </p:cNvPr>
          <p:cNvSpPr txBox="1"/>
          <p:nvPr/>
        </p:nvSpPr>
        <p:spPr>
          <a:xfrm>
            <a:off x="6269010" y="1988840"/>
            <a:ext cx="836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CHIP1</a:t>
            </a:r>
          </a:p>
        </p:txBody>
      </p: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BE280202-5CE3-0BA6-803C-C6BD991E2ECC}"/>
              </a:ext>
            </a:extLst>
          </p:cNvPr>
          <p:cNvCxnSpPr>
            <a:cxnSpLocks/>
          </p:cNvCxnSpPr>
          <p:nvPr/>
        </p:nvCxnSpPr>
        <p:spPr>
          <a:xfrm flipH="1" flipV="1">
            <a:off x="4983865" y="2179678"/>
            <a:ext cx="100811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65DACD54-9EA7-7533-31E7-B773019F8512}"/>
              </a:ext>
            </a:extLst>
          </p:cNvPr>
          <p:cNvSpPr txBox="1"/>
          <p:nvPr/>
        </p:nvSpPr>
        <p:spPr>
          <a:xfrm rot="16200000">
            <a:off x="787641" y="397480"/>
            <a:ext cx="176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OF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CD64224F-0465-55EF-36E0-32A039794DC6}"/>
              </a:ext>
            </a:extLst>
          </p:cNvPr>
          <p:cNvSpPr txBox="1"/>
          <p:nvPr/>
        </p:nvSpPr>
        <p:spPr>
          <a:xfrm rot="16200000">
            <a:off x="1104940" y="514456"/>
            <a:ext cx="176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RPV1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GOF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0FDC168D-F1B9-E763-2179-723901440207}"/>
              </a:ext>
            </a:extLst>
          </p:cNvPr>
          <p:cNvSpPr txBox="1"/>
          <p:nvPr/>
        </p:nvSpPr>
        <p:spPr>
          <a:xfrm rot="16200000">
            <a:off x="1481451" y="350400"/>
            <a:ext cx="176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OF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837C5E0-247B-B2AD-F9B2-0A634469C753}"/>
              </a:ext>
            </a:extLst>
          </p:cNvPr>
          <p:cNvSpPr txBox="1"/>
          <p:nvPr/>
        </p:nvSpPr>
        <p:spPr>
          <a:xfrm rot="16200000">
            <a:off x="1807398" y="499251"/>
            <a:ext cx="176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RPV1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GOF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E3A1CD74-095F-BD2A-3E89-47AB752CB4F6}"/>
              </a:ext>
            </a:extLst>
          </p:cNvPr>
          <p:cNvSpPr txBox="1"/>
          <p:nvPr/>
        </p:nvSpPr>
        <p:spPr>
          <a:xfrm>
            <a:off x="5991977" y="4362188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-Tubulin</a:t>
            </a:r>
          </a:p>
        </p:txBody>
      </p: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6ADCC107-85AF-07A5-B1B8-370EF2F8BEA2}"/>
              </a:ext>
            </a:extLst>
          </p:cNvPr>
          <p:cNvCxnSpPr>
            <a:cxnSpLocks/>
          </p:cNvCxnSpPr>
          <p:nvPr/>
        </p:nvCxnSpPr>
        <p:spPr>
          <a:xfrm flipH="1" flipV="1">
            <a:off x="5067722" y="4553026"/>
            <a:ext cx="100811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2899B660-7FF0-F7C0-AE15-4AE77713FB9B}"/>
              </a:ext>
            </a:extLst>
          </p:cNvPr>
          <p:cNvSpPr txBox="1"/>
          <p:nvPr/>
        </p:nvSpPr>
        <p:spPr>
          <a:xfrm>
            <a:off x="6303290" y="299013"/>
            <a:ext cx="36091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ull unedited gel for Figure </a:t>
            </a:r>
            <a:r>
              <a:rPr lang="en-CA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5H</a:t>
            </a:r>
            <a:endParaRPr lang="en-CA" dirty="0"/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0456CBF4-B631-D880-4DDD-B910428C1FF1}"/>
              </a:ext>
            </a:extLst>
          </p:cNvPr>
          <p:cNvCxnSpPr>
            <a:cxnSpLocks/>
          </p:cNvCxnSpPr>
          <p:nvPr/>
        </p:nvCxnSpPr>
        <p:spPr>
          <a:xfrm>
            <a:off x="1244343" y="1910136"/>
            <a:ext cx="243145" cy="4060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8E2AC543-86A4-220E-7393-C0DF01DEBFC4}"/>
              </a:ext>
            </a:extLst>
          </p:cNvPr>
          <p:cNvCxnSpPr>
            <a:cxnSpLocks/>
          </p:cNvCxnSpPr>
          <p:nvPr/>
        </p:nvCxnSpPr>
        <p:spPr>
          <a:xfrm flipV="1">
            <a:off x="1225427" y="2262401"/>
            <a:ext cx="262061" cy="1447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C0819B74-BF34-1A00-E92E-B869AF3A70C1}"/>
              </a:ext>
            </a:extLst>
          </p:cNvPr>
          <p:cNvSpPr txBox="1"/>
          <p:nvPr/>
        </p:nvSpPr>
        <p:spPr>
          <a:xfrm>
            <a:off x="802837" y="160352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2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7B952AF-A306-0FCA-EB6B-FDD2357F6AF4}"/>
              </a:ext>
            </a:extLst>
          </p:cNvPr>
          <p:cNvSpPr txBox="1"/>
          <p:nvPr/>
        </p:nvSpPr>
        <p:spPr>
          <a:xfrm>
            <a:off x="793379" y="2092206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2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950190E-4B89-F56A-C1AF-5D791FBFF69C}"/>
              </a:ext>
            </a:extLst>
          </p:cNvPr>
          <p:cNvSpPr txBox="1"/>
          <p:nvPr/>
        </p:nvSpPr>
        <p:spPr>
          <a:xfrm rot="16200000">
            <a:off x="2150159" y="425572"/>
            <a:ext cx="176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OF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C2F97C-0362-51A7-45C9-C2DD9075B8F5}"/>
              </a:ext>
            </a:extLst>
          </p:cNvPr>
          <p:cNvSpPr txBox="1"/>
          <p:nvPr/>
        </p:nvSpPr>
        <p:spPr>
          <a:xfrm rot="16200000">
            <a:off x="2467458" y="542548"/>
            <a:ext cx="176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RPV1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GOF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54C16DC-ED61-8348-F20E-FAD32B8A1846}"/>
              </a:ext>
            </a:extLst>
          </p:cNvPr>
          <p:cNvSpPr txBox="1"/>
          <p:nvPr/>
        </p:nvSpPr>
        <p:spPr>
          <a:xfrm rot="16200000">
            <a:off x="2843969" y="378492"/>
            <a:ext cx="176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O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59B0335-100E-9524-44E7-211572CDB01A}"/>
              </a:ext>
            </a:extLst>
          </p:cNvPr>
          <p:cNvSpPr txBox="1"/>
          <p:nvPr/>
        </p:nvSpPr>
        <p:spPr>
          <a:xfrm rot="16200000">
            <a:off x="3169916" y="527343"/>
            <a:ext cx="176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RPV1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GOF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3D21AB7-7481-5292-A69A-4BF688DAD073}"/>
              </a:ext>
            </a:extLst>
          </p:cNvPr>
          <p:cNvSpPr txBox="1"/>
          <p:nvPr/>
        </p:nvSpPr>
        <p:spPr>
          <a:xfrm rot="16200000">
            <a:off x="3521329" y="378492"/>
            <a:ext cx="176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OF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8276607-B996-445F-555E-56BA5F45F253}"/>
              </a:ext>
            </a:extLst>
          </p:cNvPr>
          <p:cNvSpPr txBox="1"/>
          <p:nvPr/>
        </p:nvSpPr>
        <p:spPr>
          <a:xfrm rot="16200000">
            <a:off x="3847276" y="527343"/>
            <a:ext cx="176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RPV1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GOF</a:t>
            </a:r>
          </a:p>
        </p:txBody>
      </p:sp>
    </p:spTree>
    <p:extLst>
      <p:ext uri="{BB962C8B-B14F-4D97-AF65-F5344CB8AC3E}">
        <p14:creationId xmlns:p14="http://schemas.microsoft.com/office/powerpoint/2010/main" val="10319574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</TotalTime>
  <Words>100</Words>
  <Application>Microsoft Office PowerPoint</Application>
  <PresentationFormat>Widescreen</PresentationFormat>
  <Paragraphs>5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on Defaye</dc:creator>
  <cp:lastModifiedBy>Christophe Altier</cp:lastModifiedBy>
  <cp:revision>11</cp:revision>
  <dcterms:created xsi:type="dcterms:W3CDTF">2023-10-06T20:11:35Z</dcterms:created>
  <dcterms:modified xsi:type="dcterms:W3CDTF">2024-01-30T16:47:34Z</dcterms:modified>
</cp:coreProperties>
</file>